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60" r:id="rId1"/>
  </p:sldMasterIdLst>
  <p:notesMasterIdLst>
    <p:notesMasterId r:id="rId15"/>
  </p:notesMasterIdLst>
  <p:sldIdLst>
    <p:sldId id="267" r:id="rId2"/>
    <p:sldId id="258" r:id="rId3"/>
    <p:sldId id="266" r:id="rId4"/>
    <p:sldId id="261" r:id="rId5"/>
    <p:sldId id="263" r:id="rId6"/>
    <p:sldId id="269" r:id="rId7"/>
    <p:sldId id="270" r:id="rId8"/>
    <p:sldId id="271" r:id="rId9"/>
    <p:sldId id="272" r:id="rId10"/>
    <p:sldId id="277" r:id="rId11"/>
    <p:sldId id="274" r:id="rId12"/>
    <p:sldId id="275" r:id="rId13"/>
    <p:sldId id="276" r:id="rId1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46"/>
  </p:normalViewPr>
  <p:slideViewPr>
    <p:cSldViewPr snapToGrid="0">
      <p:cViewPr>
        <p:scale>
          <a:sx n="95" d="100"/>
          <a:sy n="95" d="100"/>
        </p:scale>
        <p:origin x="3592" y="1120"/>
      </p:cViewPr>
      <p:guideLst>
        <p:guide orient="horz" pos="312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5A99CE-481B-4162-A754-BE3D57C1421A}" type="datetimeFigureOut">
              <a:rPr lang="en-IN" smtClean="0"/>
              <a:t>04/11/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F34097-D594-4115-A07E-4402C3617A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29187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E8D55A7-7DA2-F79B-6445-FCA15BCC18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D57F375-7F2B-A023-B93E-CD8E8D3903F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8609684-6F85-7B40-C2AF-FEB41253842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FE09DB-0B94-3A76-D2FD-963F4B54A97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6416E8-162C-4C0F-849E-922B33442B71}" type="slidenum">
              <a:rPr lang="en-IN" smtClean="0"/>
              <a:t>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41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2FBA7F-8AA4-4EC0-BB63-75DB422D8AAB}" type="datetime1">
              <a:rPr lang="en-IN" smtClean="0"/>
              <a:t>04/11/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1903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3984C-AA0C-45DA-A635-4BFD1A25E335}" type="datetime1">
              <a:rPr lang="en-IN" smtClean="0"/>
              <a:t>04/11/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27410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E8C3D-6C33-4443-AB99-EC7CBC995592}" type="datetime1">
              <a:rPr lang="en-IN" smtClean="0"/>
              <a:t>04/11/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3621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73F67-DDDE-494D-9783-3F16C2830C6B}" type="datetime1">
              <a:rPr lang="en-IN" smtClean="0"/>
              <a:t>04/11/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36496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65A5B-7CC3-4E16-97FD-874692B9AD0C}" type="datetime1">
              <a:rPr lang="en-IN" smtClean="0"/>
              <a:t>04/11/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7840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DE4BAC-9D4E-4285-B9FB-92846DB8F15D}" type="datetime1">
              <a:rPr lang="en-IN" smtClean="0"/>
              <a:t>04/11/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1338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0C6F6-4F94-49B7-9296-1F249D4DE5AF}" type="datetime1">
              <a:rPr lang="en-IN" smtClean="0"/>
              <a:t>04/11/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1568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7F632-49CD-47F1-AD78-9E7776D7CFEE}" type="datetime1">
              <a:rPr lang="en-IN" smtClean="0"/>
              <a:t>04/11/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9909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8B22A-2325-4282-B5CC-F07DC4A00D6B}" type="datetime1">
              <a:rPr lang="en-IN" smtClean="0"/>
              <a:t>04/11/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088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4F1FA-6D22-46CD-8FB8-7D1DFFEF68A9}" type="datetime1">
              <a:rPr lang="en-IN" smtClean="0"/>
              <a:t>04/11/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5196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71C99-E446-4179-9C92-8DB227A48C81}" type="datetime1">
              <a:rPr lang="en-IN" smtClean="0"/>
              <a:t>04/11/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83663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2F6C7-8BAA-4A06-9EF9-015E22C59636}" type="datetime1">
              <a:rPr lang="en-IN" smtClean="0"/>
              <a:t>04/11/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9C2D8-C95E-4408-B28F-C69E0C4C235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4252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9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11" Type="http://schemas.openxmlformats.org/officeDocument/2006/relationships/image" Target="../media/image8.emf"/><Relationship Id="rId5" Type="http://schemas.openxmlformats.org/officeDocument/2006/relationships/oleObject" Target="../embeddings/oleObject4.bin"/><Relationship Id="rId15" Type="http://schemas.openxmlformats.org/officeDocument/2006/relationships/image" Target="../media/image12.png"/><Relationship Id="rId10" Type="http://schemas.openxmlformats.org/officeDocument/2006/relationships/oleObject" Target="../embeddings/oleObject6.bin"/><Relationship Id="rId4" Type="http://schemas.openxmlformats.org/officeDocument/2006/relationships/image" Target="../media/image5.emf"/><Relationship Id="rId9" Type="http://schemas.openxmlformats.org/officeDocument/2006/relationships/image" Target="../media/image10.png"/><Relationship Id="rId14" Type="http://schemas.openxmlformats.org/officeDocument/2006/relationships/image" Target="../media/image1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7" Type="http://schemas.openxmlformats.org/officeDocument/2006/relationships/image" Target="../media/image15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oleObject" Target="../embeddings/oleObject15.bin"/><Relationship Id="rId3" Type="http://schemas.openxmlformats.org/officeDocument/2006/relationships/oleObject" Target="../embeddings/oleObject10.bin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2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7.emf"/><Relationship Id="rId11" Type="http://schemas.openxmlformats.org/officeDocument/2006/relationships/oleObject" Target="../embeddings/oleObject14.bin"/><Relationship Id="rId5" Type="http://schemas.openxmlformats.org/officeDocument/2006/relationships/oleObject" Target="../embeddings/oleObject11.bin"/><Relationship Id="rId10" Type="http://schemas.openxmlformats.org/officeDocument/2006/relationships/image" Target="../media/image19.emf"/><Relationship Id="rId4" Type="http://schemas.openxmlformats.org/officeDocument/2006/relationships/image" Target="../media/image16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tif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17.bin"/><Relationship Id="rId5" Type="http://schemas.openxmlformats.org/officeDocument/2006/relationships/image" Target="../media/image22.emf"/><Relationship Id="rId4" Type="http://schemas.openxmlformats.org/officeDocument/2006/relationships/oleObject" Target="../embeddings/oleObject16.bin"/><Relationship Id="rId9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8DB54C3-F374-EA8B-86B3-66C32B54EB0D}"/>
              </a:ext>
            </a:extLst>
          </p:cNvPr>
          <p:cNvSpPr txBox="1"/>
          <p:nvPr/>
        </p:nvSpPr>
        <p:spPr>
          <a:xfrm>
            <a:off x="453457" y="449943"/>
            <a:ext cx="5951085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kern="100" dirty="0"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Pre-exposure to time-restricted feeding reduces tissue CD4+ T cells with a limited effect on Mycobacterium tuberculosis clearance at the early time point</a:t>
            </a:r>
          </a:p>
          <a:p>
            <a:pPr>
              <a:lnSpc>
                <a:spcPct val="200000"/>
              </a:lnSpc>
            </a:pPr>
            <a:br>
              <a:rPr lang="en-IN" sz="1200" kern="100" dirty="0"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</a:br>
            <a:endParaRPr lang="en-IN" sz="1200" kern="100" dirty="0">
              <a:effectLst/>
              <a:latin typeface="Times New Roman" panose="02020603050405020304" pitchFamily="18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Ashish Gupta, Nidhi Yadav, Subhasmita Das, R. Rajendra Kumar Reddy, Nupur Sharma, Amol Ratnakar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Suryawanshi</a:t>
            </a:r>
            <a:r>
              <a:rPr lang="en-US" sz="1200" dirty="0"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, Jaswinder Singh Maras, Ranjan Kumar Nanda</a:t>
            </a:r>
            <a:endParaRPr lang="en-IN" sz="1200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495CB2-C2D9-01A0-5A97-F97BF3497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15178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6ED44AB-8474-7C47-AE52-C3EEDA107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10</a:t>
            </a:fld>
            <a:endParaRPr lang="en-IN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D71DEDE-C63E-5D4D-87A3-5447FD205A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0823723"/>
              </p:ext>
            </p:extLst>
          </p:nvPr>
        </p:nvGraphicFramePr>
        <p:xfrm>
          <a:off x="484934" y="687015"/>
          <a:ext cx="4853547" cy="799081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39283">
                  <a:extLst>
                    <a:ext uri="{9D8B030D-6E8A-4147-A177-3AD203B41FA5}">
                      <a16:colId xmlns:a16="http://schemas.microsoft.com/office/drawing/2014/main" val="3922705504"/>
                    </a:ext>
                  </a:extLst>
                </a:gridCol>
                <a:gridCol w="539283">
                  <a:extLst>
                    <a:ext uri="{9D8B030D-6E8A-4147-A177-3AD203B41FA5}">
                      <a16:colId xmlns:a16="http://schemas.microsoft.com/office/drawing/2014/main" val="2137022946"/>
                    </a:ext>
                  </a:extLst>
                </a:gridCol>
                <a:gridCol w="539283">
                  <a:extLst>
                    <a:ext uri="{9D8B030D-6E8A-4147-A177-3AD203B41FA5}">
                      <a16:colId xmlns:a16="http://schemas.microsoft.com/office/drawing/2014/main" val="1192246506"/>
                    </a:ext>
                  </a:extLst>
                </a:gridCol>
                <a:gridCol w="539283">
                  <a:extLst>
                    <a:ext uri="{9D8B030D-6E8A-4147-A177-3AD203B41FA5}">
                      <a16:colId xmlns:a16="http://schemas.microsoft.com/office/drawing/2014/main" val="833445682"/>
                    </a:ext>
                  </a:extLst>
                </a:gridCol>
                <a:gridCol w="539283">
                  <a:extLst>
                    <a:ext uri="{9D8B030D-6E8A-4147-A177-3AD203B41FA5}">
                      <a16:colId xmlns:a16="http://schemas.microsoft.com/office/drawing/2014/main" val="3600546079"/>
                    </a:ext>
                  </a:extLst>
                </a:gridCol>
                <a:gridCol w="539283">
                  <a:extLst>
                    <a:ext uri="{9D8B030D-6E8A-4147-A177-3AD203B41FA5}">
                      <a16:colId xmlns:a16="http://schemas.microsoft.com/office/drawing/2014/main" val="1230803207"/>
                    </a:ext>
                  </a:extLst>
                </a:gridCol>
                <a:gridCol w="539283">
                  <a:extLst>
                    <a:ext uri="{9D8B030D-6E8A-4147-A177-3AD203B41FA5}">
                      <a16:colId xmlns:a16="http://schemas.microsoft.com/office/drawing/2014/main" val="2209473796"/>
                    </a:ext>
                  </a:extLst>
                </a:gridCol>
                <a:gridCol w="539283">
                  <a:extLst>
                    <a:ext uri="{9D8B030D-6E8A-4147-A177-3AD203B41FA5}">
                      <a16:colId xmlns:a16="http://schemas.microsoft.com/office/drawing/2014/main" val="3213798109"/>
                    </a:ext>
                  </a:extLst>
                </a:gridCol>
                <a:gridCol w="539283">
                  <a:extLst>
                    <a:ext uri="{9D8B030D-6E8A-4147-A177-3AD203B41FA5}">
                      <a16:colId xmlns:a16="http://schemas.microsoft.com/office/drawing/2014/main" val="3631232663"/>
                    </a:ext>
                  </a:extLst>
                </a:gridCol>
              </a:tblGrid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56701842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dx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6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15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t2a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6.40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1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d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7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03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8302059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dx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591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18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2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6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g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0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8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79945415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x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26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x1bp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5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79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p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2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774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93018013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ot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7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34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xndc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45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rgl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2213858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t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4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1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xnr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4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12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i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0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92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91018911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17b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32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12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xnrd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0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4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1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8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56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3611215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pox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5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17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xn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0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93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t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2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35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158356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x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9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3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td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7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04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t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9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67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3391327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t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1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98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co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4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1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o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9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6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13107122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tpn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6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54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ngo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8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76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l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2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50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55543247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tpn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7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75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a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330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9406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l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8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02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8621712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k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4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30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i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2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29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rc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5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7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28144902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m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0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m3-rs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6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59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om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64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24568690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081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20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m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6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5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6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18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91954997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s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77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12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qln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0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38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2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3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79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13009460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xnb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1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47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e2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2E-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f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5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67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78186163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z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88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90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e2i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5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9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0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5157398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n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3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73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xn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17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e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33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7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96410044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n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4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59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pk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32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21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7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4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97526853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a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66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66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0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4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4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4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62276490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gr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3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43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es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4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07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s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3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0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32298908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gr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0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5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t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9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a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7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1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389990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ss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9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01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oc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23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06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o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4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97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8070188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e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85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6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gp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06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2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5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7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21944670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e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54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8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d23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5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38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6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2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70304327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4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6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h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10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79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tn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6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95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60995120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a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8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4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s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4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9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n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84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4998861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a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77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3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wa5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2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5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646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42024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a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3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93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dr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1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12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ufa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6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7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76849773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a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8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66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pnpe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2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8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ufb1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04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97241024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a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1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82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zg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0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5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ufv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4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2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7967643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a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8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7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cr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8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5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n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838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36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898275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70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1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d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6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11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hlrc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9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8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62286703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85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4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a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5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x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6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3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544333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1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1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65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hfs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76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xo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5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68980827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2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31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hf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4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68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h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3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86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76515752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4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70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bi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2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01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i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0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6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73285181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4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7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y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76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if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07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0687355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2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1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ss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0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7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cr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0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69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6932982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2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7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md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9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952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e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2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12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59690258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2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08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m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0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28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am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0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24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1540906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mb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3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77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0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6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1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60493478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4h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14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51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gd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9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22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qb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4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6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27433616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m136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2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5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s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8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2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r2m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346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932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5392670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m1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5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3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sg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8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040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w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2657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1678620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m1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2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68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39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2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861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38001763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prk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6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43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pd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806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x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9575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08923181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9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954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5f1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5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8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m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0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7496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46530010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n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72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4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x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0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npo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7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5526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8577770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c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9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85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b41l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6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07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x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5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2266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35333048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2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8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3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2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5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1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2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6653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24865451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2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9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9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s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41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11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5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4742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04244216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pb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21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2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hi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35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72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5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6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8E-05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50838578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l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5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2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nf2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90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5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53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62442177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yz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3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30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acam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9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6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7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2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3E-05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49858781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mtor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4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yb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01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l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5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1E-05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13778479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b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0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73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dc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2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2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p1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3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0088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64866173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as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50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81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dc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50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g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3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9271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61411787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e6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2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32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apd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7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47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og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45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06276366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k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5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1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a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5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87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l1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2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841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34660739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ase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3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86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1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l10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8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610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0756609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kbh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6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49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r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40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7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1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793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8322616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o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7.26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66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rp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85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ptin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2723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25933454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14l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06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76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3E-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pe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1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6E-06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45122794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phs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8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1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x4i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0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99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rp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3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2989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56254817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phs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0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6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ync1li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7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89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s1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485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42531049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lenbp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7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0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rps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0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183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36313384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ptin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1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24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3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k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9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817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01530022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pina3k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3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51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r2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8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1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38a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9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947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81501607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m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3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0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jb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4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12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r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0963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65479095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p2c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6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56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jb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0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5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tbn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1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2E-06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59208966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p2c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1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27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n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6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5E-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f3b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6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3359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25690450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p5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0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89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if2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3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161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fpq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6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971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8071014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p1c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69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06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if3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85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5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16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8009119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p1c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0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37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if4g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0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sb1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9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0885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98057769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f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5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03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if4g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4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sb4x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1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165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77532676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pinb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6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55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wsr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3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8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r1ai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0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2868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60874362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3bgrl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6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2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m107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07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r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2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049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44790593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3bgrl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6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8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b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7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35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c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5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7019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51691377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d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7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9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pd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44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u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3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224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7877589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r1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3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1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pda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0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37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ap2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6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8568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75623857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hd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2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75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rx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8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760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dv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5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947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58613324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1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9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9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x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1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88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mp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039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58362221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1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0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87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53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p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3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8057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3100358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o1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4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64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6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224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88104123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ri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0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4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r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30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33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41870583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dx39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1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7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7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7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8766847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ryd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5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g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66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42208441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d1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6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43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hf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84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9854930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d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5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8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a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1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87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81027087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d1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6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2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a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7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72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72186789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p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0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89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ra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6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4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43462881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pa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6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40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6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9000792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6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31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s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8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11146919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lg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3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6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-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9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31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34745750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la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3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86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-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6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27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18072709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lg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9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62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2ac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6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00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40041214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c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39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6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2bc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3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83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58411055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t1c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33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33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hfe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3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4155544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6052297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733817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C1C13D27-E566-C149-9ADC-0EBB7C69F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11</a:t>
            </a:fld>
            <a:endParaRPr lang="en-IN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BDDEEF6-C199-6842-B830-56F26FFC5AF7}"/>
              </a:ext>
            </a:extLst>
          </p:cNvPr>
          <p:cNvSpPr/>
          <p:nvPr/>
        </p:nvSpPr>
        <p:spPr>
          <a:xfrm>
            <a:off x="220980" y="251936"/>
            <a:ext cx="654558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4. List of deregulated metabolites between the ALF-TB and TRF-TB mice in serum at 21 days post infection.</a:t>
            </a:r>
            <a:r>
              <a:rPr lang="en-US" dirty="0"/>
              <a:t>		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D11F833-5801-2144-9A6B-5C543B64CC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5038942"/>
              </p:ext>
            </p:extLst>
          </p:nvPr>
        </p:nvGraphicFramePr>
        <p:xfrm>
          <a:off x="318770" y="805934"/>
          <a:ext cx="5549900" cy="4673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198896">
                  <a:extLst>
                    <a:ext uri="{9D8B030D-6E8A-4147-A177-3AD203B41FA5}">
                      <a16:colId xmlns:a16="http://schemas.microsoft.com/office/drawing/2014/main" val="505825683"/>
                    </a:ext>
                  </a:extLst>
                </a:gridCol>
                <a:gridCol w="675502">
                  <a:extLst>
                    <a:ext uri="{9D8B030D-6E8A-4147-A177-3AD203B41FA5}">
                      <a16:colId xmlns:a16="http://schemas.microsoft.com/office/drawing/2014/main" val="2892720805"/>
                    </a:ext>
                  </a:extLst>
                </a:gridCol>
                <a:gridCol w="675502">
                  <a:extLst>
                    <a:ext uri="{9D8B030D-6E8A-4147-A177-3AD203B41FA5}">
                      <a16:colId xmlns:a16="http://schemas.microsoft.com/office/drawing/2014/main" val="178547090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c features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372479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(Uracil-1-yl)-L-alanine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809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7E-05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255819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yl(2R_3S)-2-methyl-3-hydroxybutanoate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35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778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175645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(O-20:0/20:0)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94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16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544142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(17:1(9Z)/22:6(4Z,7Z,10Z,13Z,16Z,19Z))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70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099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0924898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tamin D3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839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74958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FA(6:0)]3Z-hexenol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22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9865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649553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a-Hydroxyestrone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5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505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1193294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Methylpropanaloxim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04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2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300698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-hydroxy-10E,16-heptadecadien-8-yno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96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67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523912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opurpuricin 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008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207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8696263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trydial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46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356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680345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rP(d18:1/16:0)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129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318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0739169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rP(d18:1/18:0)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71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1203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859990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rP(d18:1/20:0)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529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6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8586113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teromycin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026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4751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889286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inacarboline A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4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42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009137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 (Z)-3-(3,4-dihydroxyphenyl)-2-formamidoacrylat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99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6817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943990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-Ribosylnicotinamid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36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71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779805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(12:0/0:0)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049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212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16559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(17:2(9Z,12Z)/0:0)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899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945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239225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(18:3(6Z,9Z,12Z)/0:0)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74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645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8813368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keleimide A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296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8392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998765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3370339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6A2FDA4-50BA-BF4D-8B8C-5CDCB384C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12</a:t>
            </a:fld>
            <a:endParaRPr lang="en-IN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A7DF69F-AC48-B449-B138-3B64F1202B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0957035"/>
              </p:ext>
            </p:extLst>
          </p:nvPr>
        </p:nvGraphicFramePr>
        <p:xfrm>
          <a:off x="370840" y="736600"/>
          <a:ext cx="5791201" cy="3048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440871">
                  <a:extLst>
                    <a:ext uri="{9D8B030D-6E8A-4147-A177-3AD203B41FA5}">
                      <a16:colId xmlns:a16="http://schemas.microsoft.com/office/drawing/2014/main" val="209597266"/>
                    </a:ext>
                  </a:extLst>
                </a:gridCol>
                <a:gridCol w="675165">
                  <a:extLst>
                    <a:ext uri="{9D8B030D-6E8A-4147-A177-3AD203B41FA5}">
                      <a16:colId xmlns:a16="http://schemas.microsoft.com/office/drawing/2014/main" val="3471214395"/>
                    </a:ext>
                  </a:extLst>
                </a:gridCol>
                <a:gridCol w="675165">
                  <a:extLst>
                    <a:ext uri="{9D8B030D-6E8A-4147-A177-3AD203B41FA5}">
                      <a16:colId xmlns:a16="http://schemas.microsoft.com/office/drawing/2014/main" val="3596806989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c features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1974278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3-Dimethoxyphenylpyruvic acid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067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215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5630114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ramin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52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77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423742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-Hydroxythiophenol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0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9084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734421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gatofuranos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007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56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457827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3,4,5-Tetrahydroxypentanoic acid-1,4-lactone, tris(trimethylsilyl)-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82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784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1738724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Butyn-2-amine, 2-methyl-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64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79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80888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Methoxy-4-methylheptan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944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264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1902730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-Methyl-1,3-thiazole-5-carboxyl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18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07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91823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,12-Octadecadieno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076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46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638908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-Tetradeceno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335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594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5933318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bonolacton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385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85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3072457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os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247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8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1087208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nylethanolamin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01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16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6812139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staglandin D(2)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24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096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04133508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A87DED9F-B103-1941-B203-A302B049203A}"/>
              </a:ext>
            </a:extLst>
          </p:cNvPr>
          <p:cNvSpPr/>
          <p:nvPr/>
        </p:nvSpPr>
        <p:spPr>
          <a:xfrm>
            <a:off x="370840" y="166191"/>
            <a:ext cx="587756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5. List of deregulated metabolites between the ALF-TB and TRF-TB mice in the liver at 21 days post infection.</a:t>
            </a:r>
            <a:endParaRPr lang="en-IN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40976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0CBE5AB8-635E-B34C-BDD9-BFDA5B697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13</a:t>
            </a:fld>
            <a:endParaRPr lang="en-IN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052584D-0B8A-8E44-B097-786FFC7A8201}"/>
              </a:ext>
            </a:extLst>
          </p:cNvPr>
          <p:cNvSpPr/>
          <p:nvPr/>
        </p:nvSpPr>
        <p:spPr>
          <a:xfrm>
            <a:off x="373380" y="262096"/>
            <a:ext cx="618998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6. List of deregulated proteins between the ALF-TB and TRF-TB mice in the liver at 21 days post infection.		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9EDE3D3-C47F-C341-A50A-6E9A549312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7597960"/>
              </p:ext>
            </p:extLst>
          </p:nvPr>
        </p:nvGraphicFramePr>
        <p:xfrm>
          <a:off x="772160" y="896938"/>
          <a:ext cx="2082800" cy="737434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31520">
                  <a:extLst>
                    <a:ext uri="{9D8B030D-6E8A-4147-A177-3AD203B41FA5}">
                      <a16:colId xmlns:a16="http://schemas.microsoft.com/office/drawing/2014/main" val="3459277934"/>
                    </a:ext>
                  </a:extLst>
                </a:gridCol>
                <a:gridCol w="721360">
                  <a:extLst>
                    <a:ext uri="{9D8B030D-6E8A-4147-A177-3AD203B41FA5}">
                      <a16:colId xmlns:a16="http://schemas.microsoft.com/office/drawing/2014/main" val="2863810529"/>
                    </a:ext>
                  </a:extLst>
                </a:gridCol>
                <a:gridCol w="629920">
                  <a:extLst>
                    <a:ext uri="{9D8B030D-6E8A-4147-A177-3AD203B41FA5}">
                      <a16:colId xmlns:a16="http://schemas.microsoft.com/office/drawing/2014/main" val="1163325740"/>
                    </a:ext>
                  </a:extLst>
                </a:gridCol>
              </a:tblGrid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732707848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cr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65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73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147694283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1a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94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4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086290688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if2a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90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6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421679114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if3j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34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1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464799862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barapl1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10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3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245092580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ca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35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65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66593855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t1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9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5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694787501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m1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010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6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943146293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nbp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6406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4E-0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029764656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iad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84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1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14286795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gfr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101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0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102076726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ss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29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8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04468288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m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087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75861591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11b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75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05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602072981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bp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61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7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021837692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mbp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40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2E-0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586129444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yref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24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66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426029069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y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39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03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84294925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bxn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67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5E-0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469903156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pt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78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7E-0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934849312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c1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71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7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653531674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d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46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6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45222644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bi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75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8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570649145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pap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32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6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29528963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74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57002248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5pf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59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0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248041998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2m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13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2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35353290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pp1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92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3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190662681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r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3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71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13634381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s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0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75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194575512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l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9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0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677399078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b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76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7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339593256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tb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9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4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391141602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ip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55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2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012725519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x5a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95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3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075268816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sp2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7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823162212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ynlrb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08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1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4169709159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ge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69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3E-0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4117518195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bp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38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2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391942261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a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89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0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413400663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nrnpa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03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6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596719474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b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88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9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653135743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p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4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72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741168469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8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75672050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00a1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53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0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152896267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epps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67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866596625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15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6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28063602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c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12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4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136408871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hgdib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122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2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611252582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k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02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821047335"/>
                  </a:ext>
                </a:extLst>
              </a:tr>
              <a:tr h="200658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00002D01Rik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38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82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1072331689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haf4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40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8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612624488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sb10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816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75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948894284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sb4x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877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9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2554963679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fc1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383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5E-05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995250044"/>
                  </a:ext>
                </a:extLst>
              </a:tr>
              <a:tr h="108647">
                <a:tc>
                  <a:txBody>
                    <a:bodyPr/>
                    <a:lstStyle/>
                    <a:p>
                      <a:pPr algn="l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dd8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79</a:t>
                      </a:r>
                      <a:endParaRPr lang="en-I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59</a:t>
                      </a:r>
                      <a:endParaRPr lang="en-I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93" marR="5093" marT="5093" marB="0" anchor="b"/>
                </a:tc>
                <a:extLst>
                  <a:ext uri="{0D108BD9-81ED-4DB2-BD59-A6C34878D82A}">
                    <a16:rowId xmlns:a16="http://schemas.microsoft.com/office/drawing/2014/main" val="39554881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58966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98385AB-F0A8-FAFD-531F-ABBDE053EC8E}"/>
              </a:ext>
            </a:extLst>
          </p:cNvPr>
          <p:cNvSpPr txBox="1"/>
          <p:nvPr/>
        </p:nvSpPr>
        <p:spPr>
          <a:xfrm>
            <a:off x="490220" y="194522"/>
            <a:ext cx="152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0B5076D-C208-59B4-7F6B-05B7B973231E}"/>
              </a:ext>
            </a:extLst>
          </p:cNvPr>
          <p:cNvSpPr txBox="1"/>
          <p:nvPr/>
        </p:nvSpPr>
        <p:spPr>
          <a:xfrm>
            <a:off x="522134" y="461610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1C2B895-D7D9-4EE0-74DA-B33726234B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8172454"/>
              </p:ext>
            </p:extLst>
          </p:nvPr>
        </p:nvGraphicFramePr>
        <p:xfrm>
          <a:off x="2955802" y="2117054"/>
          <a:ext cx="1104792" cy="15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8" r:id="rId3" imgW="2445889" imgH="2420022" progId="Prism8.Document">
                  <p:embed/>
                </p:oleObj>
              </mc:Choice>
              <mc:Fallback>
                <p:oleObj name="Prism 8" r:id="rId3" imgW="2445889" imgH="2420022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1C2B895-D7D9-4EE0-74DA-B33726234B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55802" y="2117054"/>
                        <a:ext cx="1104792" cy="15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311D421-877D-738E-D97B-00C4968F4A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6133969"/>
              </p:ext>
            </p:extLst>
          </p:nvPr>
        </p:nvGraphicFramePr>
        <p:xfrm>
          <a:off x="498004" y="2224776"/>
          <a:ext cx="2648272" cy="1476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8" r:id="rId5" imgW="3794278" imgH="2640678" progId="Prism8.Document">
                  <p:embed/>
                </p:oleObj>
              </mc:Choice>
              <mc:Fallback>
                <p:oleObj name="Prism 8" r:id="rId5" imgW="3794278" imgH="2640678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311D421-877D-738E-D97B-00C4968F4A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8004" y="2224776"/>
                        <a:ext cx="2648272" cy="1476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7EF603DD-55A8-84A5-12CF-947149D6C77A}"/>
              </a:ext>
            </a:extLst>
          </p:cNvPr>
          <p:cNvSpPr txBox="1"/>
          <p:nvPr/>
        </p:nvSpPr>
        <p:spPr>
          <a:xfrm>
            <a:off x="522134" y="2063193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C00280-3254-5657-C3F8-8845CE280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2</a:t>
            </a:fld>
            <a:endParaRPr lang="en-IN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D147C3B-714C-8273-8A6C-BFFA1DBBBFB1}"/>
              </a:ext>
            </a:extLst>
          </p:cNvPr>
          <p:cNvSpPr txBox="1"/>
          <p:nvPr/>
        </p:nvSpPr>
        <p:spPr>
          <a:xfrm>
            <a:off x="67056" y="3583588"/>
            <a:ext cx="6723888" cy="225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Supplementary Figure S1. TRF decreased body weight and improved glucose homeostasis initially. A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Percentage body weight changes at Day 7 and 14 post-TRF.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B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Intraperitoneal glucose tolerance test at Day 21 post-TRF. The quantification of the AUC above baseline is shown in the insert. Each dot represents a biological replicate. Statistical significance was determined using unpaired t-test with Welch’s correction in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A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and two-way repeated-measures ANOVA and Sidak’s multiple comparisons tests for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ipGTT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and unpaired t-test with Welch’s correction for AUC in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B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8" name="Picture 7" descr="A screenshot of a computer&#10;&#10;AI-generated content may be incorrect.">
            <a:extLst>
              <a:ext uri="{FF2B5EF4-FFF2-40B4-BE49-F238E27FC236}">
                <a16:creationId xmlns:a16="http://schemas.microsoft.com/office/drawing/2014/main" id="{D732D4E5-E305-7813-44FB-2884C33734F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01" t="5591" r="16346" b="5275"/>
          <a:stretch>
            <a:fillRect/>
          </a:stretch>
        </p:blipFill>
        <p:spPr>
          <a:xfrm>
            <a:off x="526879" y="623193"/>
            <a:ext cx="1295261" cy="1440000"/>
          </a:xfrm>
          <a:prstGeom prst="rect">
            <a:avLst/>
          </a:prstGeom>
        </p:spPr>
      </p:pic>
      <p:pic>
        <p:nvPicPr>
          <p:cNvPr id="14" name="Picture 13" descr="A screenshot of a computer&#10;&#10;AI-generated content may be incorrect.">
            <a:extLst>
              <a:ext uri="{FF2B5EF4-FFF2-40B4-BE49-F238E27FC236}">
                <a16:creationId xmlns:a16="http://schemas.microsoft.com/office/drawing/2014/main" id="{C0127899-A43C-24BC-E21C-4FE0F265C68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5" t="6850" r="16071" b="4331"/>
          <a:stretch>
            <a:fillRect/>
          </a:stretch>
        </p:blipFill>
        <p:spPr>
          <a:xfrm>
            <a:off x="2133740" y="633926"/>
            <a:ext cx="1295260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8268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20B1CE9-D3DC-56C7-86F9-477387D6E9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6324748"/>
              </p:ext>
            </p:extLst>
          </p:nvPr>
        </p:nvGraphicFramePr>
        <p:xfrm>
          <a:off x="509588" y="590550"/>
          <a:ext cx="1104900" cy="1273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9" name="Prism 8" r:id="rId3" imgW="2237116" imgH="2578405" progId="Prism8.Document">
                  <p:embed/>
                </p:oleObj>
              </mc:Choice>
              <mc:Fallback>
                <p:oleObj name="Prism 8" r:id="rId3" imgW="2237116" imgH="2578405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20B1CE9-D3DC-56C7-86F9-477387D6E9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9588" y="590550"/>
                        <a:ext cx="1104900" cy="1273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2EF167E-4675-05F4-EE97-554232B0E5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60231"/>
              </p:ext>
            </p:extLst>
          </p:nvPr>
        </p:nvGraphicFramePr>
        <p:xfrm>
          <a:off x="1463675" y="593725"/>
          <a:ext cx="1166813" cy="1266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0" name="Prism 8" r:id="rId5" imgW="2358780" imgH="2562927" progId="Prism8.Document">
                  <p:embed/>
                </p:oleObj>
              </mc:Choice>
              <mc:Fallback>
                <p:oleObj name="Prism 8" r:id="rId5" imgW="2358780" imgH="2562927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2EF167E-4675-05F4-EE97-554232B0E5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63675" y="593725"/>
                        <a:ext cx="1166813" cy="1266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B357971-09F4-5E23-A655-FD3BB997F7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5708656"/>
              </p:ext>
            </p:extLst>
          </p:nvPr>
        </p:nvGraphicFramePr>
        <p:xfrm>
          <a:off x="2478088" y="584200"/>
          <a:ext cx="1106487" cy="1285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1" name="Prism 8" r:id="rId7" imgW="2237116" imgH="2601083" progId="Prism8.Document">
                  <p:embed/>
                </p:oleObj>
              </mc:Choice>
              <mc:Fallback>
                <p:oleObj name="Prism 8" r:id="rId7" imgW="2237116" imgH="2601083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8B357971-09F4-5E23-A655-FD3BB997F7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478088" y="584200"/>
                        <a:ext cx="1106487" cy="1285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104FEF1-2E0B-4881-DF2C-5ADD957A2E15}"/>
              </a:ext>
            </a:extLst>
          </p:cNvPr>
          <p:cNvSpPr txBox="1"/>
          <p:nvPr/>
        </p:nvSpPr>
        <p:spPr>
          <a:xfrm>
            <a:off x="500380" y="126794"/>
            <a:ext cx="152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8FB7D00-69B8-7C77-85AB-F5CBF3E76EBA}"/>
              </a:ext>
            </a:extLst>
          </p:cNvPr>
          <p:cNvSpPr txBox="1"/>
          <p:nvPr/>
        </p:nvSpPr>
        <p:spPr>
          <a:xfrm>
            <a:off x="461815" y="458050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A39C03-5378-492A-CD00-A487D6808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3</a:t>
            </a:fld>
            <a:endParaRPr lang="en-IN"/>
          </a:p>
        </p:txBody>
      </p:sp>
      <p:pic>
        <p:nvPicPr>
          <p:cNvPr id="7" name="Picture 6" descr="A computer screen shot of a computer&#10;&#10;Description automatically generated">
            <a:extLst>
              <a:ext uri="{FF2B5EF4-FFF2-40B4-BE49-F238E27FC236}">
                <a16:creationId xmlns:a16="http://schemas.microsoft.com/office/drawing/2014/main" id="{C9BEBCB5-C479-5EC6-1A68-CE4EDFA7B69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405" b="62477"/>
          <a:stretch/>
        </p:blipFill>
        <p:spPr>
          <a:xfrm>
            <a:off x="3576175" y="458050"/>
            <a:ext cx="2314086" cy="1708856"/>
          </a:xfrm>
          <a:prstGeom prst="rect">
            <a:avLst/>
          </a:prstGeom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A6EA39A-A6AB-3C3B-2A76-555B1F8DA0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4562791"/>
              </p:ext>
            </p:extLst>
          </p:nvPr>
        </p:nvGraphicFramePr>
        <p:xfrm>
          <a:off x="500380" y="2187898"/>
          <a:ext cx="242982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2" name="Prism 8" r:id="rId10" imgW="3824874" imgH="2694313" progId="Prism8.Document">
                  <p:embed/>
                </p:oleObj>
              </mc:Choice>
              <mc:Fallback>
                <p:oleObj name="Prism 8" r:id="rId10" imgW="3824874" imgH="2694313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7A6EA39A-A6AB-3C3B-2A76-555B1F8DA0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00380" y="2187898"/>
                        <a:ext cx="242982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78EE14E6-5A77-E00B-1C6C-5844CB573F05}"/>
              </a:ext>
            </a:extLst>
          </p:cNvPr>
          <p:cNvSpPr txBox="1"/>
          <p:nvPr/>
        </p:nvSpPr>
        <p:spPr>
          <a:xfrm>
            <a:off x="3319426" y="458050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3264AC3-146A-7D10-9116-BE39844E5A14}"/>
              </a:ext>
            </a:extLst>
          </p:cNvPr>
          <p:cNvSpPr txBox="1"/>
          <p:nvPr/>
        </p:nvSpPr>
        <p:spPr>
          <a:xfrm>
            <a:off x="510011" y="2129479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46C0A2C-F568-43DE-6306-246A0B657F31}"/>
              </a:ext>
            </a:extLst>
          </p:cNvPr>
          <p:cNvSpPr txBox="1"/>
          <p:nvPr/>
        </p:nvSpPr>
        <p:spPr>
          <a:xfrm>
            <a:off x="2669571" y="2132978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EF6844D-63C0-A247-C068-18F4E6BDEA0F}"/>
              </a:ext>
            </a:extLst>
          </p:cNvPr>
          <p:cNvSpPr txBox="1"/>
          <p:nvPr/>
        </p:nvSpPr>
        <p:spPr>
          <a:xfrm>
            <a:off x="500380" y="4042818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3307A9C2-53F0-12F2-34C4-DAC0900B85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9666254"/>
              </p:ext>
            </p:extLst>
          </p:nvPr>
        </p:nvGraphicFramePr>
        <p:xfrm>
          <a:off x="461815" y="4129992"/>
          <a:ext cx="2899203" cy="15177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3" name="Prism 8" r:id="rId12" imgW="3839992" imgH="2689633" progId="Prism8.Document">
                  <p:embed/>
                </p:oleObj>
              </mc:Choice>
              <mc:Fallback>
                <p:oleObj name="Prism 8" r:id="rId12" imgW="3839992" imgH="268963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61815" y="4129992"/>
                        <a:ext cx="2899203" cy="15177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8B9D834A-A9F7-4E0F-E227-CE660E32024C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2" t="6766" r="39748" b="3854"/>
          <a:stretch>
            <a:fillRect/>
          </a:stretch>
        </p:blipFill>
        <p:spPr>
          <a:xfrm>
            <a:off x="2898350" y="2309000"/>
            <a:ext cx="2429827" cy="17984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35A061C-CD43-5725-321C-F0E878CD081A}"/>
              </a:ext>
            </a:extLst>
          </p:cNvPr>
          <p:cNvSpPr txBox="1"/>
          <p:nvPr/>
        </p:nvSpPr>
        <p:spPr>
          <a:xfrm>
            <a:off x="48768" y="6360471"/>
            <a:ext cx="6559296" cy="33600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2. TRF induces metabolic remodeling in the liver. A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lative abundance of palmitoleic acid, cytidine, and cystine in the serum measured by using GC-M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chematic representation of the method used for metabolite profiling from the TRF and ALF mice liver using GC-M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incipal component analysis (PCA) of the liver metabolites between the TRF and ALF 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Volcano plot showing the deregulated metabolites in the liver of the TRF and ALF 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etabolite set enrichment analysis (MSEA) of the deregulated metabolites. Size of the dot represents the enrichment ratio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airwise correlation of significantly deregulated (p-value ≤ 0.05; log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ld change ALF/TRF≥±1.0) proteins and metabolites in the liver. Statistical significance was determined using unpaired t-test with Welch’s correction in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Each dot represents a biological replicate.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10ADDF8-8488-0B42-1CE2-2F14A1DEF339}"/>
              </a:ext>
            </a:extLst>
          </p:cNvPr>
          <p:cNvSpPr txBox="1"/>
          <p:nvPr/>
        </p:nvSpPr>
        <p:spPr>
          <a:xfrm>
            <a:off x="3100278" y="4076552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19" descr="A diagram of a graph&#10;&#10;AI-generated content may be incorrect.">
            <a:extLst>
              <a:ext uri="{FF2B5EF4-FFF2-40B4-BE49-F238E27FC236}">
                <a16:creationId xmlns:a16="http://schemas.microsoft.com/office/drawing/2014/main" id="{6FF3467B-F3A3-5267-7EBD-1D92D53C2896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72" t="2470" r="6162" b="6563"/>
          <a:stretch>
            <a:fillRect/>
          </a:stretch>
        </p:blipFill>
        <p:spPr>
          <a:xfrm>
            <a:off x="3291414" y="4258262"/>
            <a:ext cx="2450353" cy="2183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93390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58EE08F-8E43-C915-DC61-19EC330913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9017D2F-78AC-ED68-948D-FA73BE1D6FED}"/>
              </a:ext>
            </a:extLst>
          </p:cNvPr>
          <p:cNvSpPr txBox="1"/>
          <p:nvPr/>
        </p:nvSpPr>
        <p:spPr>
          <a:xfrm>
            <a:off x="459740" y="100740"/>
            <a:ext cx="152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ED5819D-653A-09E3-F635-C028B5523096}"/>
              </a:ext>
            </a:extLst>
          </p:cNvPr>
          <p:cNvSpPr txBox="1"/>
          <p:nvPr/>
        </p:nvSpPr>
        <p:spPr>
          <a:xfrm>
            <a:off x="459740" y="470139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4F4135E-56CB-B77C-C7F6-685AC45F07D3}"/>
              </a:ext>
            </a:extLst>
          </p:cNvPr>
          <p:cNvSpPr txBox="1"/>
          <p:nvPr/>
        </p:nvSpPr>
        <p:spPr>
          <a:xfrm>
            <a:off x="1678867" y="475458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FA23877B-644E-DD2A-987D-AF38E190DD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4611201"/>
              </p:ext>
            </p:extLst>
          </p:nvPr>
        </p:nvGraphicFramePr>
        <p:xfrm>
          <a:off x="460375" y="701675"/>
          <a:ext cx="1438275" cy="1744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name="Prism 8" r:id="rId3" imgW="2328544" imgH="2448819" progId="Prism8.Document">
                  <p:embed/>
                </p:oleObj>
              </mc:Choice>
              <mc:Fallback>
                <p:oleObj name="Prism 8" r:id="rId3" imgW="2328544" imgH="2448819" progId="Prism8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FA23877B-644E-DD2A-987D-AF38E190DD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0375" y="701675"/>
                        <a:ext cx="1438275" cy="1744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EB586E7-EA4F-45BB-3B7D-425805EA7117}"/>
              </a:ext>
            </a:extLst>
          </p:cNvPr>
          <p:cNvSpPr txBox="1"/>
          <p:nvPr/>
        </p:nvSpPr>
        <p:spPr>
          <a:xfrm>
            <a:off x="4619516" y="508022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928211-384E-7336-A9D7-1379FD3D5C7E}"/>
              </a:ext>
            </a:extLst>
          </p:cNvPr>
          <p:cNvSpPr txBox="1"/>
          <p:nvPr/>
        </p:nvSpPr>
        <p:spPr>
          <a:xfrm>
            <a:off x="908138" y="651279"/>
            <a:ext cx="1029220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dpi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C978265-9546-7FF5-1120-40ECF8679B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1067272"/>
              </p:ext>
            </p:extLst>
          </p:nvPr>
        </p:nvGraphicFramePr>
        <p:xfrm>
          <a:off x="4729163" y="615950"/>
          <a:ext cx="1543050" cy="1746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6" name="Prism 8" r:id="rId5" imgW="2000626" imgH="2759826" progId="Prism8.Document">
                  <p:embed/>
                </p:oleObj>
              </mc:Choice>
              <mc:Fallback>
                <p:oleObj name="Prism 8" r:id="rId5" imgW="2000626" imgH="2759826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C978265-9546-7FF5-1120-40ECF8679B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29163" y="615950"/>
                        <a:ext cx="1543050" cy="1746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7222D6C9-EF4D-3457-C634-D1278CE702FF}"/>
              </a:ext>
            </a:extLst>
          </p:cNvPr>
          <p:cNvSpPr txBox="1"/>
          <p:nvPr/>
        </p:nvSpPr>
        <p:spPr>
          <a:xfrm>
            <a:off x="5369040" y="581440"/>
            <a:ext cx="1029220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 dpi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E710A8-422F-2EF8-0F2B-475A57E88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4</a:t>
            </a:fld>
            <a:endParaRPr lang="en-IN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6CD2BF8-D047-3104-0753-1C72DFF01A4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3" t="5957" r="7835" b="4793"/>
          <a:stretch>
            <a:fillRect/>
          </a:stretch>
        </p:blipFill>
        <p:spPr>
          <a:xfrm>
            <a:off x="1937358" y="701675"/>
            <a:ext cx="2441538" cy="172384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2367D25-8F96-3C42-144E-914328E96FB0}"/>
              </a:ext>
            </a:extLst>
          </p:cNvPr>
          <p:cNvSpPr txBox="1"/>
          <p:nvPr/>
        </p:nvSpPr>
        <p:spPr>
          <a:xfrm>
            <a:off x="79248" y="2538021"/>
            <a:ext cx="6723888" cy="15133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Supplementary Figure S3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.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Mice were infected with 100-400 colony forming unit of Mtb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A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Lung mycobacterial burden at 1 day post infection (dpi).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B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Percentage difference in bodyweight between the ALF-TB and TRF-TB mice.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C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Random blood glucose levels at 21 dpi. Each dot represents a biological replicate.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9920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33E2AA2-EB34-BC0F-43A3-329E4EC994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98416FF3-057C-E451-C9FE-2BCD4F56E084}"/>
              </a:ext>
            </a:extLst>
          </p:cNvPr>
          <p:cNvSpPr txBox="1"/>
          <p:nvPr/>
        </p:nvSpPr>
        <p:spPr>
          <a:xfrm>
            <a:off x="499196" y="104965"/>
            <a:ext cx="17180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CEA616-19C9-A2A9-5A49-09D7788642A7}"/>
              </a:ext>
            </a:extLst>
          </p:cNvPr>
          <p:cNvSpPr txBox="1"/>
          <p:nvPr/>
        </p:nvSpPr>
        <p:spPr>
          <a:xfrm>
            <a:off x="458788" y="480512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EBCF49F-3FFA-EBB1-9B58-D969C40449E7}"/>
              </a:ext>
            </a:extLst>
          </p:cNvPr>
          <p:cNvSpPr txBox="1"/>
          <p:nvPr/>
        </p:nvSpPr>
        <p:spPr>
          <a:xfrm>
            <a:off x="2711370" y="480512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CD13241-3026-AB9A-D6AC-7CDD6ADE1745}"/>
              </a:ext>
            </a:extLst>
          </p:cNvPr>
          <p:cNvSpPr txBox="1"/>
          <p:nvPr/>
        </p:nvSpPr>
        <p:spPr>
          <a:xfrm>
            <a:off x="513497" y="2223196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6BAF619-B075-C876-C6EE-C84E00CF5122}"/>
              </a:ext>
            </a:extLst>
          </p:cNvPr>
          <p:cNvSpPr txBox="1"/>
          <p:nvPr/>
        </p:nvSpPr>
        <p:spPr>
          <a:xfrm>
            <a:off x="1114335" y="541926"/>
            <a:ext cx="111157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ne marrow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FA505340-BA10-88D7-9A6A-F2EAEB1109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1150707"/>
              </p:ext>
            </p:extLst>
          </p:nvPr>
        </p:nvGraphicFramePr>
        <p:xfrm>
          <a:off x="1548948" y="716027"/>
          <a:ext cx="1107286" cy="151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3" name="Prism 8" r:id="rId3" imgW="2392256" imgH="2759826" progId="Prism8.Document">
                  <p:embed/>
                </p:oleObj>
              </mc:Choice>
              <mc:Fallback>
                <p:oleObj name="Prism 8" r:id="rId3" imgW="2392256" imgH="2759826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FA505340-BA10-88D7-9A6A-F2EAEB1109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48948" y="716027"/>
                        <a:ext cx="1107286" cy="151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15B6A303-60B0-05B2-AF2C-0DFC5B3417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0401862"/>
              </p:ext>
            </p:extLst>
          </p:nvPr>
        </p:nvGraphicFramePr>
        <p:xfrm>
          <a:off x="488421" y="711196"/>
          <a:ext cx="1115549" cy="151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4" name="Prism 8" r:id="rId5" imgW="2194281" imgH="2759826" progId="Prism8.Document">
                  <p:embed/>
                </p:oleObj>
              </mc:Choice>
              <mc:Fallback>
                <p:oleObj name="Prism 8" r:id="rId5" imgW="2194281" imgH="2759826" progId="Prism8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15B6A303-60B0-05B2-AF2C-0DFC5B3417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8421" y="711196"/>
                        <a:ext cx="1115549" cy="151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CD4D0BE9-CECC-E1B0-485A-A44ED427E722}"/>
              </a:ext>
            </a:extLst>
          </p:cNvPr>
          <p:cNvSpPr txBox="1"/>
          <p:nvPr/>
        </p:nvSpPr>
        <p:spPr>
          <a:xfrm>
            <a:off x="3782051" y="522592"/>
            <a:ext cx="691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ngs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8D7B7DE6-C3D8-851C-2884-70C4A23C9B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894349"/>
              </p:ext>
            </p:extLst>
          </p:nvPr>
        </p:nvGraphicFramePr>
        <p:xfrm>
          <a:off x="2931775" y="715352"/>
          <a:ext cx="1111572" cy="151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5" name="Prism 8" r:id="rId7" imgW="2194281" imgH="2759826" progId="Prism8.Document">
                  <p:embed/>
                </p:oleObj>
              </mc:Choice>
              <mc:Fallback>
                <p:oleObj name="Prism 8" r:id="rId7" imgW="2194281" imgH="2759826" progId="Prism8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8D7B7DE6-C3D8-851C-2884-70C4A23C9B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931775" y="715352"/>
                        <a:ext cx="1111572" cy="151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342834C4-36AA-6DA8-06C9-C39304248A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7609684"/>
              </p:ext>
            </p:extLst>
          </p:nvPr>
        </p:nvGraphicFramePr>
        <p:xfrm>
          <a:off x="4043347" y="683952"/>
          <a:ext cx="1119200" cy="151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6" name="Prism 8" r:id="rId9" imgW="2308747" imgH="2759826" progId="Prism8.Document">
                  <p:embed/>
                </p:oleObj>
              </mc:Choice>
              <mc:Fallback>
                <p:oleObj name="Prism 8" r:id="rId9" imgW="2308747" imgH="2759826" progId="Prism8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342834C4-36AA-6DA8-06C9-C39304248A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43347" y="683952"/>
                        <a:ext cx="1119200" cy="151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9C84F6C5-54FE-256C-5D65-2C23459098AA}"/>
              </a:ext>
            </a:extLst>
          </p:cNvPr>
          <p:cNvSpPr txBox="1"/>
          <p:nvPr/>
        </p:nvSpPr>
        <p:spPr>
          <a:xfrm>
            <a:off x="1295848" y="2271853"/>
            <a:ext cx="648417" cy="2793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en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4AA9BADE-2AC1-92CE-5039-E68A117318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2090885"/>
              </p:ext>
            </p:extLst>
          </p:nvPr>
        </p:nvGraphicFramePr>
        <p:xfrm>
          <a:off x="504508" y="2443471"/>
          <a:ext cx="1115549" cy="1512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7" name="Prism 8" r:id="rId11" imgW="2217318" imgH="2759826" progId="Prism8.Document">
                  <p:embed/>
                </p:oleObj>
              </mc:Choice>
              <mc:Fallback>
                <p:oleObj name="Prism 8" r:id="rId11" imgW="2217318" imgH="2759826" progId="Prism8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4AA9BADE-2AC1-92CE-5039-E68A117318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04508" y="2443471"/>
                        <a:ext cx="1115549" cy="1512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4C0A6550-7B84-AA21-5140-BA7E2DB4FA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0556366"/>
              </p:ext>
            </p:extLst>
          </p:nvPr>
        </p:nvGraphicFramePr>
        <p:xfrm>
          <a:off x="1587500" y="2436813"/>
          <a:ext cx="1108075" cy="1517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8" name="Prism 8" r:id="rId13" imgW="2308747" imgH="2848016" progId="Prism8.Document">
                  <p:embed/>
                </p:oleObj>
              </mc:Choice>
              <mc:Fallback>
                <p:oleObj name="Prism 8" r:id="rId13" imgW="2308747" imgH="2848016" progId="Prism8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4C0A6550-7B84-AA21-5140-BA7E2DB4FA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587500" y="2436813"/>
                        <a:ext cx="1108075" cy="1517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AFE5A0BF-EE92-86A7-EEEF-84C1C3337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5</a:t>
            </a:fld>
            <a:endParaRPr lang="en-IN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397B21B-9070-D8BA-A4E6-75D40CD26F84}"/>
              </a:ext>
            </a:extLst>
          </p:cNvPr>
          <p:cNvSpPr txBox="1"/>
          <p:nvPr/>
        </p:nvSpPr>
        <p:spPr>
          <a:xfrm>
            <a:off x="73152" y="4123868"/>
            <a:ext cx="6693408" cy="11440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Supplementary Figure S4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.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Absolute number of CD3</a:t>
            </a:r>
            <a:r>
              <a:rPr lang="en-US" sz="1200" b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+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and CD3</a:t>
            </a:r>
            <a:r>
              <a:rPr lang="en-US" sz="1200" b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+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CD4</a:t>
            </a:r>
            <a:r>
              <a:rPr lang="en-US" sz="1200" b="1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+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 T cells in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A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) bone marrow, 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B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) lungs and (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C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) spleen at 21 dpi. Each dot represents a biological replicate. Statistical significance was determined using unpaired t-test with Welch’s correction. *p≤0.05 and **p≤0.01.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81873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88A83B-C1C9-C5F5-A907-A6AFC4EFC1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8C36B350-3375-F31A-6387-D57710ECE241}"/>
              </a:ext>
            </a:extLst>
          </p:cNvPr>
          <p:cNvSpPr txBox="1"/>
          <p:nvPr/>
        </p:nvSpPr>
        <p:spPr>
          <a:xfrm>
            <a:off x="467522" y="473604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039A351-11A8-0A41-F3A8-0212E676075A}"/>
              </a:ext>
            </a:extLst>
          </p:cNvPr>
          <p:cNvSpPr txBox="1"/>
          <p:nvPr/>
        </p:nvSpPr>
        <p:spPr>
          <a:xfrm>
            <a:off x="2724801" y="473604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AB821D-E97E-7F8C-8FE2-E70EAFD7315F}"/>
              </a:ext>
            </a:extLst>
          </p:cNvPr>
          <p:cNvSpPr txBox="1"/>
          <p:nvPr/>
        </p:nvSpPr>
        <p:spPr>
          <a:xfrm>
            <a:off x="476766" y="2337539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10DE1C-88E3-B2EE-7CCD-C77B323BF039}"/>
              </a:ext>
            </a:extLst>
          </p:cNvPr>
          <p:cNvSpPr txBox="1"/>
          <p:nvPr/>
        </p:nvSpPr>
        <p:spPr>
          <a:xfrm>
            <a:off x="467521" y="161575"/>
            <a:ext cx="16546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490168E8-D178-3692-C6DB-F719464D04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937062"/>
              </p:ext>
            </p:extLst>
          </p:nvPr>
        </p:nvGraphicFramePr>
        <p:xfrm>
          <a:off x="488950" y="517525"/>
          <a:ext cx="2343150" cy="1616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3" name="Prism 8" r:id="rId4" imgW="3818755" imgH="2787183" progId="Prism8.Document">
                  <p:embed/>
                </p:oleObj>
              </mc:Choice>
              <mc:Fallback>
                <p:oleObj name="Prism 8" r:id="rId4" imgW="3818755" imgH="2787183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490168E8-D178-3692-C6DB-F719464D04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8950" y="517525"/>
                        <a:ext cx="2343150" cy="1616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DF79493-56BE-8F85-64BC-785A0FAE27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1498347"/>
              </p:ext>
            </p:extLst>
          </p:nvPr>
        </p:nvGraphicFramePr>
        <p:xfrm>
          <a:off x="488950" y="2428792"/>
          <a:ext cx="2678417" cy="15220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4" name="Prism 8" r:id="rId6" imgW="4731599" imgH="2689633" progId="Prism8.Document">
                  <p:embed/>
                </p:oleObj>
              </mc:Choice>
              <mc:Fallback>
                <p:oleObj name="Prism 8" r:id="rId6" imgW="4731599" imgH="268963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88950" y="2428792"/>
                        <a:ext cx="2678417" cy="15220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D79801DB-797C-6D52-6BDC-BEE5586AA2B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3" t="6315" r="44038" b="4914"/>
          <a:stretch>
            <a:fillRect/>
          </a:stretch>
        </p:blipFill>
        <p:spPr>
          <a:xfrm>
            <a:off x="2943949" y="591659"/>
            <a:ext cx="2349856" cy="16632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8DD652B-981D-80D8-563C-BFE768331A14}"/>
              </a:ext>
            </a:extLst>
          </p:cNvPr>
          <p:cNvSpPr txBox="1"/>
          <p:nvPr/>
        </p:nvSpPr>
        <p:spPr>
          <a:xfrm>
            <a:off x="164592" y="7256399"/>
            <a:ext cx="6693408" cy="225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+mn-ea"/>
              </a:rPr>
              <a:t>Supplementary Figure S5. TRF induced changes in the liver metabolome persists post Mtb infection. A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incipal component analysis of the liver metabolites between the ALF-TB and TRF-TB ALF 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Volcano plot showing the deregulated metabolites in the liver of the ALF-TB and TRF-TB mic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etabolite set enrichment analysis of the deregulated metabolites. Size of the dot represents the enrichment ratio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airwise correlation of significantly deregulated (p-value ≤ 0.05; log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old change ALF-TB/TRF-TB≥±1.0) proteins and metabolites in the liver.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5" name="Picture 4" descr="A diagram of a graph&#10;&#10;AI-generated content may be incorrect.">
            <a:extLst>
              <a:ext uri="{FF2B5EF4-FFF2-40B4-BE49-F238E27FC236}">
                <a16:creationId xmlns:a16="http://schemas.microsoft.com/office/drawing/2014/main" id="{5C820E70-CCAF-4515-F5CF-FB013367046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8" t="13896" r="6888" b="5935"/>
          <a:stretch>
            <a:fillRect/>
          </a:stretch>
        </p:blipFill>
        <p:spPr>
          <a:xfrm>
            <a:off x="311819" y="3994603"/>
            <a:ext cx="5235541" cy="33722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10F3625-4DDD-668E-4F12-82828BC2F58C}"/>
              </a:ext>
            </a:extLst>
          </p:cNvPr>
          <p:cNvSpPr txBox="1"/>
          <p:nvPr/>
        </p:nvSpPr>
        <p:spPr>
          <a:xfrm>
            <a:off x="488950" y="3986769"/>
            <a:ext cx="2191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51923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4AF79233-4808-444D-AA55-F2967DBED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7</a:t>
            </a:fld>
            <a:endParaRPr lang="en-IN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479C6B5-1FCB-B941-9E81-9E32A6470DA0}"/>
              </a:ext>
            </a:extLst>
          </p:cNvPr>
          <p:cNvSpPr/>
          <p:nvPr/>
        </p:nvSpPr>
        <p:spPr>
          <a:xfrm>
            <a:off x="379413" y="217716"/>
            <a:ext cx="60071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1. List of deregulated metabolites between the ALF and TRF mice in serum after 30 days of TRF.		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AD47A889-2516-794C-B743-0B91E20D14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2742982"/>
              </p:ext>
            </p:extLst>
          </p:nvPr>
        </p:nvGraphicFramePr>
        <p:xfrm>
          <a:off x="538480" y="679381"/>
          <a:ext cx="4123224" cy="86446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911848">
                  <a:extLst>
                    <a:ext uri="{9D8B030D-6E8A-4147-A177-3AD203B41FA5}">
                      <a16:colId xmlns:a16="http://schemas.microsoft.com/office/drawing/2014/main" val="1253208734"/>
                    </a:ext>
                  </a:extLst>
                </a:gridCol>
                <a:gridCol w="605688">
                  <a:extLst>
                    <a:ext uri="{9D8B030D-6E8A-4147-A177-3AD203B41FA5}">
                      <a16:colId xmlns:a16="http://schemas.microsoft.com/office/drawing/2014/main" val="3692814727"/>
                    </a:ext>
                  </a:extLst>
                </a:gridCol>
                <a:gridCol w="605688">
                  <a:extLst>
                    <a:ext uri="{9D8B030D-6E8A-4147-A177-3AD203B41FA5}">
                      <a16:colId xmlns:a16="http://schemas.microsoft.com/office/drawing/2014/main" val="4005526016"/>
                    </a:ext>
                  </a:extLst>
                </a:gridCol>
              </a:tblGrid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c features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406467174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rostenedion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6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50655385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abulenol B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7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690693907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-desoxy-19,20-epoxycytochalasin C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6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686855161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ilotetrin B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6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832682318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magillin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3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697586556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hydroepiheveadrid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6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786131703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tophilin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5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963938480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rP(d18:1/16:0)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1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416539784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-Epiiridotrial glucosid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7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095050238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starhamnose B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8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456357633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G(17:2(9Z,12Z)/20:3(8Z,11Z,14Z)/0:0)[iso2]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8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385804281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desmethyl tocotrienol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2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4056974164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ukamycin C-II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5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161726105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-Ribosylimidazole)-4-acetate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4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348067917"/>
                  </a:ext>
                </a:extLst>
              </a:tr>
              <a:tr h="243167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 10-acetoxy-8,9-epoxy-2Z-decen-4,6-diynoat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9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4294227237"/>
                  </a:ext>
                </a:extLst>
              </a:tr>
              <a:tr h="243167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-Hydroxyluteolin 6,3'-dimethyl ether 7,4'-disulfat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5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097676795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-propyl arachidonoyl amin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8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286302583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ilosteroid B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6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753429750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_4-Dihydroxyphenylethyleneglycol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6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853129536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rP(d18:1/18:0)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3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816424079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paracemosone 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7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604834759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chloroacetic 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0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877585762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_4.6-Trichloroanisol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29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726382870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eptomyceamide</a:t>
                      </a:r>
                      <a:r>
                        <a:rPr lang="en-IN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18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538419440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angulyne 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5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787352734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10-dimethyl 4-hydroxy-6-oxo-4-undecen-7-yn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1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534755101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rfugin A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0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47439783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-acetamido-1-hydroxyethyl)phosphonic 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880436610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xadecanedioic 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592295034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raminic 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642632594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onecyanohydrin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845660166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Z)-Octadecenoic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263681271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xadecanoic 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2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11520907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rylamid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3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703681152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Hydroxy-2-methylbutyronitril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425911907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9,12,15,18,21-Tetracosahexaynoic 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6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182244454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luen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7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971671819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MethylpropanalO-methyloxim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708357453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_4-Lacton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52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853225582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nolic stero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6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742282860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idin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0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957554512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methyl-2Z-hexenoic 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4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1188027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thophosphat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5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436100748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lmitoleic 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1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111504578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opromycin B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2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78040452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)-1-Pyrroline-5-carboxylat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40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891991591"/>
                  </a:ext>
                </a:extLst>
              </a:tr>
              <a:tr h="243167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alpha-fluoro-25-hydroxy-16,17,23,23,24,24-hexadehydrovitamin D3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68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3089944582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3,6-Octatriene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66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839293126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(17:0/20:4(5Z,8Z,11Z,14Z))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57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1457956159"/>
                  </a:ext>
                </a:extLst>
              </a:tr>
              <a:tr h="243167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-dichloro-3,7-dihydroxy-1,9-dimethyldibenzofuran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6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5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2741441601"/>
                  </a:ext>
                </a:extLst>
              </a:tr>
              <a:tr h="128090">
                <a:tc>
                  <a:txBody>
                    <a:bodyPr/>
                    <a:lstStyle/>
                    <a:p>
                      <a:pPr algn="l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-Hydroxydodecanoicacid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81</a:t>
                      </a:r>
                      <a:endParaRPr lang="en-I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2" marR="5402" marT="5402" marB="0" anchor="b"/>
                </a:tc>
                <a:extLst>
                  <a:ext uri="{0D108BD9-81ED-4DB2-BD59-A6C34878D82A}">
                    <a16:rowId xmlns:a16="http://schemas.microsoft.com/office/drawing/2014/main" val="7441693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824081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266C16F6-32D9-9348-ACC3-EA49F48E1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8</a:t>
            </a:fld>
            <a:endParaRPr lang="en-IN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7C1B57F-F20C-3E41-9E11-1852144EAC3F}"/>
              </a:ext>
            </a:extLst>
          </p:cNvPr>
          <p:cNvSpPr/>
          <p:nvPr/>
        </p:nvSpPr>
        <p:spPr>
          <a:xfrm>
            <a:off x="332740" y="217716"/>
            <a:ext cx="62509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2. List of deregulated metabolites between the ALF and TRF mice in the liver after 30 days of TRF.		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DD4EE922-2F29-A942-B4AD-F098242426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6777776"/>
              </p:ext>
            </p:extLst>
          </p:nvPr>
        </p:nvGraphicFramePr>
        <p:xfrm>
          <a:off x="444500" y="840740"/>
          <a:ext cx="3294380" cy="1731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93900">
                  <a:extLst>
                    <a:ext uri="{9D8B030D-6E8A-4147-A177-3AD203B41FA5}">
                      <a16:colId xmlns:a16="http://schemas.microsoft.com/office/drawing/2014/main" val="2723569781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2716776599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255386365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c features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4000778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ano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648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10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9331315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male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62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612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1165265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sin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736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756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8374886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-Glucon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117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277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2965302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zaldehyde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8358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923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0447060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bonolactone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712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9642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8349594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-Arabinon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863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2095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7219867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-Undecynoic acid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281</a:t>
                      </a:r>
                      <a:endParaRPr lang="en-I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8862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344175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970288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D425A55-1F9A-1C40-8C4D-EE73B03E3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9C2D8-C95E-4408-B28F-C69E0C4C235C}" type="slidenum">
              <a:rPr lang="en-IN" smtClean="0"/>
              <a:t>9</a:t>
            </a:fld>
            <a:endParaRPr lang="en-IN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F75C284-CB5A-F847-A7D3-C28BF3350777}"/>
              </a:ext>
            </a:extLst>
          </p:cNvPr>
          <p:cNvSpPr/>
          <p:nvPr/>
        </p:nvSpPr>
        <p:spPr>
          <a:xfrm>
            <a:off x="353060" y="258356"/>
            <a:ext cx="613918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3. List of deregulated proteins between the ALF and TRF mice in the liver after 30 days of TRF.	</a:t>
            </a:r>
            <a:r>
              <a:rPr lang="en-US" dirty="0"/>
              <a:t>	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E578C10B-3D7F-A746-AAFF-BB5AF3583F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3225259"/>
              </p:ext>
            </p:extLst>
          </p:nvPr>
        </p:nvGraphicFramePr>
        <p:xfrm>
          <a:off x="609600" y="1137920"/>
          <a:ext cx="5481918" cy="799081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102">
                  <a:extLst>
                    <a:ext uri="{9D8B030D-6E8A-4147-A177-3AD203B41FA5}">
                      <a16:colId xmlns:a16="http://schemas.microsoft.com/office/drawing/2014/main" val="3647006462"/>
                    </a:ext>
                  </a:extLst>
                </a:gridCol>
                <a:gridCol w="609102">
                  <a:extLst>
                    <a:ext uri="{9D8B030D-6E8A-4147-A177-3AD203B41FA5}">
                      <a16:colId xmlns:a16="http://schemas.microsoft.com/office/drawing/2014/main" val="3153477660"/>
                    </a:ext>
                  </a:extLst>
                </a:gridCol>
                <a:gridCol w="609102">
                  <a:extLst>
                    <a:ext uri="{9D8B030D-6E8A-4147-A177-3AD203B41FA5}">
                      <a16:colId xmlns:a16="http://schemas.microsoft.com/office/drawing/2014/main" val="27057041"/>
                    </a:ext>
                  </a:extLst>
                </a:gridCol>
                <a:gridCol w="609102">
                  <a:extLst>
                    <a:ext uri="{9D8B030D-6E8A-4147-A177-3AD203B41FA5}">
                      <a16:colId xmlns:a16="http://schemas.microsoft.com/office/drawing/2014/main" val="3918222918"/>
                    </a:ext>
                  </a:extLst>
                </a:gridCol>
                <a:gridCol w="609102">
                  <a:extLst>
                    <a:ext uri="{9D8B030D-6E8A-4147-A177-3AD203B41FA5}">
                      <a16:colId xmlns:a16="http://schemas.microsoft.com/office/drawing/2014/main" val="1558904414"/>
                    </a:ext>
                  </a:extLst>
                </a:gridCol>
                <a:gridCol w="609102">
                  <a:extLst>
                    <a:ext uri="{9D8B030D-6E8A-4147-A177-3AD203B41FA5}">
                      <a16:colId xmlns:a16="http://schemas.microsoft.com/office/drawing/2014/main" val="1379602223"/>
                    </a:ext>
                  </a:extLst>
                </a:gridCol>
                <a:gridCol w="609102">
                  <a:extLst>
                    <a:ext uri="{9D8B030D-6E8A-4147-A177-3AD203B41FA5}">
                      <a16:colId xmlns:a16="http://schemas.microsoft.com/office/drawing/2014/main" val="430698235"/>
                    </a:ext>
                  </a:extLst>
                </a:gridCol>
                <a:gridCol w="609102">
                  <a:extLst>
                    <a:ext uri="{9D8B030D-6E8A-4147-A177-3AD203B41FA5}">
                      <a16:colId xmlns:a16="http://schemas.microsoft.com/office/drawing/2014/main" val="2708158514"/>
                    </a:ext>
                  </a:extLst>
                </a:gridCol>
                <a:gridCol w="609102">
                  <a:extLst>
                    <a:ext uri="{9D8B030D-6E8A-4147-A177-3AD203B41FA5}">
                      <a16:colId xmlns:a16="http://schemas.microsoft.com/office/drawing/2014/main" val="630770728"/>
                    </a:ext>
                  </a:extLst>
                </a:gridCol>
              </a:tblGrid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2 F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alu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86913509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17b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8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02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nm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88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2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a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306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32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53986408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e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6.634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6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5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65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49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34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76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39400923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e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9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55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0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3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7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74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22316115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11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0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25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24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yg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32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7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30662179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wha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2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1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6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17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yg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9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8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50802308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whaq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0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49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f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6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76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od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67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59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00096492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g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0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09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z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9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08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hp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1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00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4994493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cg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3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51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cam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4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05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pel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30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007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9963107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o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6.53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04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c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19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764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p2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0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7772370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c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9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85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c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52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51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k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4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4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54623790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bc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5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26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x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7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02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p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72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50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33180891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a1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0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1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1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2-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7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54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7333358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a1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72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3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00lg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1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54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2-Q1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3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9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98655313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bd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6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49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l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30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99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2-A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1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831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57002999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a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5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53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l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2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21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pa1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4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12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97349616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9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97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qb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6.43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49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pa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26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45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7510990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d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6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8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5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pa4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4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1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7097135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a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35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8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ne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1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5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ox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0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84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34326292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la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5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2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3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1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nrnp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86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462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7811188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p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2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65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zi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5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50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nrnpa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7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37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3592326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t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1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4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pdl3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5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06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nrnpa2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6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2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30950120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9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61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o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2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95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k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7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98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30603038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t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6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55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a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6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2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6p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9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38969908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t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3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s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3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99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8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23611263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l6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23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qcrc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9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8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75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53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70005800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r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81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20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7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g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9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66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7323127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pc1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6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52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ndp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5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65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kk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1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74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70603655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pc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08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77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za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90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73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cs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5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9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17813598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pc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5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9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h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4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722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ou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1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6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17002425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pc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8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3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1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15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h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3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10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26546295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pc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2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7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4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1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88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lc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7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8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94162029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pc1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4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70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guok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6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1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se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67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09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98545714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r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84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07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st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7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0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m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2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826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930838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e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3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8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hf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62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41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c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1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4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26889095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t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4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12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8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e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9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49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55295649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na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4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5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py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9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5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ih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97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42012007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t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24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60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gd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74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cu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5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410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5761510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sm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2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33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pp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6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98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ah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2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671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49813131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sm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3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12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pp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70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1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c2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23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74329377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7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0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t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7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63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c2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2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7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67054315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t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8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6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ajc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9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98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h3g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0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51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757607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m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0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06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l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83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99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h3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5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37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1867460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k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5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50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hd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4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8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nu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06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1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96334904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nt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95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22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ge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33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9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ncl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01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31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78844767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t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41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1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ef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1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701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ta4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3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99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81599934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f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83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o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3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08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lo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5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88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13038430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f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1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64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a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2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1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30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38658679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f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4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2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p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6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3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b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60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788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60839521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f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2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90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b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3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72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p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8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53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50311128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t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45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c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4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8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6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27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96719341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8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12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hdc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35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86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p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64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10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87291035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1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9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22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f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04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9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p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75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73155715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1a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4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01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o1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3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84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p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186</a:t>
                      </a:r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5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89457910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6.08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04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c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2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89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p2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18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47511274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ox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2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2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yt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16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15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p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0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31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18910675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ox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1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48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if4ebp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240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p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2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6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15712991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ox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4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26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z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17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6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p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5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92334915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c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3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08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pz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6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5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pp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1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02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26145168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6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11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pza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63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88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mpp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00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17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0177907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b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4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07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pz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15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5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pi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6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80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13783926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5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00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ps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0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12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sf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37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886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5757898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b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0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03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scn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5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185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dm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10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40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9917570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f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75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650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bp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60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4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t2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3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2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29501324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pina1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99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cgr2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55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53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p1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9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00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26680399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p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1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63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x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2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78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6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4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90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79875065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xa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9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5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3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832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tl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05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87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4604342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xa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4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5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gy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2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58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t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32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03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65740942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xa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5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3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g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9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3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1lc3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4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27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32235754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fm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7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40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vr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3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92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en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4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16089185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rs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00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907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x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7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t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270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7940054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mc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7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5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o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6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9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pc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5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71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9214105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t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8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204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o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4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7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k1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22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1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54496623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npe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63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6E-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o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18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56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6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1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92955847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5f1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67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369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65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4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cs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2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9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65444164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5f1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7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26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m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2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96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ge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13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36542050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e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2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110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8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06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herf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4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192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05295446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ly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5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36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1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78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gk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3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7661789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k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73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50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1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6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y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166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56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40366879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km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3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53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als3bp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9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7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k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8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90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99805588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pss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3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414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barapl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22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2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k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6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04893065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hx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52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15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i30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26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39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ufa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650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51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227458721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i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95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1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n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8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3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b5r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8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68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41410193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a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3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88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6pdx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1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637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7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39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52027817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vr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3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85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2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1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ah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7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E-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009812027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dt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9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00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p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50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4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p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5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9082745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m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65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11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rx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06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58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pr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6.064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591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30492485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324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85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dh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185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17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prt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104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400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4863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u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959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32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a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3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4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lc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70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39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59516266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29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m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82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99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t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2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68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5617731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7.32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509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m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82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447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gfr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59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74358482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r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60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015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m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33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739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na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08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49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15540253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1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1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844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m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7.00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71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k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744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719636933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1f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930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m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687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28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k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32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038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39278638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3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58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36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t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6.46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2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i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3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400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085514765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3b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23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98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m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70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79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ic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08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066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484974352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2f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46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092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p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933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431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id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97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47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2024595776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b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74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13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k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14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428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kbp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452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1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260152330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b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8319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17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d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6816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12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dx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907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8651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145858160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a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423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175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d1l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415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3734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dx2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1463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5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5018</a:t>
                      </a:r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856188554"/>
                  </a:ext>
                </a:extLst>
              </a:tr>
              <a:tr h="69727"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IN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917" marR="2917" marT="2917" marB="0" anchor="b"/>
                </a:tc>
                <a:extLst>
                  <a:ext uri="{0D108BD9-81ED-4DB2-BD59-A6C34878D82A}">
                    <a16:rowId xmlns:a16="http://schemas.microsoft.com/office/drawing/2014/main" val="33635001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08495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55</TotalTime>
  <Words>3651</Words>
  <Application>Microsoft Macintosh PowerPoint</Application>
  <PresentationFormat>A4 Paper (210x297 mm)</PresentationFormat>
  <Paragraphs>2277</Paragraphs>
  <Slides>13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1" baseType="lpstr">
      <vt:lpstr>Yu Gothic</vt:lpstr>
      <vt:lpstr>Aptos</vt:lpstr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weta Chaudhary</dc:creator>
  <cp:lastModifiedBy>Microsoft Office User</cp:lastModifiedBy>
  <cp:revision>51</cp:revision>
  <dcterms:created xsi:type="dcterms:W3CDTF">2025-01-06T22:19:31Z</dcterms:created>
  <dcterms:modified xsi:type="dcterms:W3CDTF">2025-11-04T11:52:06Z</dcterms:modified>
</cp:coreProperties>
</file>